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9" r:id="rId2"/>
    <p:sldId id="276" r:id="rId3"/>
    <p:sldId id="267" r:id="rId4"/>
    <p:sldId id="274" r:id="rId5"/>
    <p:sldId id="275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113" d="100"/>
          <a:sy n="113" d="100"/>
        </p:scale>
        <p:origin x="51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25" d="100"/>
        <a:sy n="125" d="100"/>
      </p:scale>
      <p:origin x="0" y="-4932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17960-A4F4-4AA0-ACF8-B88699B5A4F1}" type="datetimeFigureOut">
              <a:rPr lang="en-US" smtClean="0"/>
              <a:t>6/2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B6C60-574D-4EBC-BA34-4DD77D5E08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47386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17960-A4F4-4AA0-ACF8-B88699B5A4F1}" type="datetimeFigureOut">
              <a:rPr lang="en-US" smtClean="0"/>
              <a:t>6/2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B6C60-574D-4EBC-BA34-4DD77D5E08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99152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17960-A4F4-4AA0-ACF8-B88699B5A4F1}" type="datetimeFigureOut">
              <a:rPr lang="en-US" smtClean="0"/>
              <a:t>6/2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B6C60-574D-4EBC-BA34-4DD77D5E08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32587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17960-A4F4-4AA0-ACF8-B88699B5A4F1}" type="datetimeFigureOut">
              <a:rPr lang="en-US" smtClean="0"/>
              <a:t>6/2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B6C60-574D-4EBC-BA34-4DD77D5E08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15513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17960-A4F4-4AA0-ACF8-B88699B5A4F1}" type="datetimeFigureOut">
              <a:rPr lang="en-US" smtClean="0"/>
              <a:t>6/2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B6C60-574D-4EBC-BA34-4DD77D5E08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88369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17960-A4F4-4AA0-ACF8-B88699B5A4F1}" type="datetimeFigureOut">
              <a:rPr lang="en-US" smtClean="0"/>
              <a:t>6/2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B6C60-574D-4EBC-BA34-4DD77D5E08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38996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17960-A4F4-4AA0-ACF8-B88699B5A4F1}" type="datetimeFigureOut">
              <a:rPr lang="en-US" smtClean="0"/>
              <a:t>6/26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B6C60-574D-4EBC-BA34-4DD77D5E08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80351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17960-A4F4-4AA0-ACF8-B88699B5A4F1}" type="datetimeFigureOut">
              <a:rPr lang="en-US" smtClean="0"/>
              <a:t>6/26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B6C60-574D-4EBC-BA34-4DD77D5E08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12093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17960-A4F4-4AA0-ACF8-B88699B5A4F1}" type="datetimeFigureOut">
              <a:rPr lang="en-US" smtClean="0"/>
              <a:t>6/26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B6C60-574D-4EBC-BA34-4DD77D5E08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53171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17960-A4F4-4AA0-ACF8-B88699B5A4F1}" type="datetimeFigureOut">
              <a:rPr lang="en-US" smtClean="0"/>
              <a:t>6/2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B6C60-574D-4EBC-BA34-4DD77D5E08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32374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17960-A4F4-4AA0-ACF8-B88699B5A4F1}" type="datetimeFigureOut">
              <a:rPr lang="en-US" smtClean="0"/>
              <a:t>6/2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B6C60-574D-4EBC-BA34-4DD77D5E08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23064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917960-A4F4-4AA0-ACF8-B88699B5A4F1}" type="datetimeFigureOut">
              <a:rPr lang="en-US" smtClean="0"/>
              <a:t>6/2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4B6C60-574D-4EBC-BA34-4DD77D5E08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16744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269"/>
          <a:stretch/>
        </p:blipFill>
        <p:spPr>
          <a:xfrm>
            <a:off x="4772938" y="390617"/>
            <a:ext cx="2589543" cy="6467383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497149" y="390617"/>
            <a:ext cx="11001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1.</a:t>
            </a: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3"/>
          <a:srcRect t="9352" r="47868" b="77477"/>
          <a:stretch/>
        </p:blipFill>
        <p:spPr>
          <a:xfrm rot="16200000">
            <a:off x="7507267" y="5276705"/>
            <a:ext cx="1628714" cy="510620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 rot="19814581">
            <a:off x="5419821" y="126272"/>
            <a:ext cx="4882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Early</a:t>
            </a:r>
          </a:p>
        </p:txBody>
      </p:sp>
      <p:sp>
        <p:nvSpPr>
          <p:cNvPr id="7" name="TextBox 6"/>
          <p:cNvSpPr txBox="1"/>
          <p:nvPr/>
        </p:nvSpPr>
        <p:spPr>
          <a:xfrm rot="19719907">
            <a:off x="5851944" y="126884"/>
            <a:ext cx="4315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Mid</a:t>
            </a:r>
          </a:p>
        </p:txBody>
      </p:sp>
      <p:sp>
        <p:nvSpPr>
          <p:cNvPr id="8" name="TextBox 7"/>
          <p:cNvSpPr txBox="1"/>
          <p:nvPr/>
        </p:nvSpPr>
        <p:spPr>
          <a:xfrm rot="20084718">
            <a:off x="6158037" y="139468"/>
            <a:ext cx="4476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te</a:t>
            </a:r>
          </a:p>
        </p:txBody>
      </p:sp>
      <p:sp>
        <p:nvSpPr>
          <p:cNvPr id="9" name="TextBox 8"/>
          <p:cNvSpPr txBox="1"/>
          <p:nvPr/>
        </p:nvSpPr>
        <p:spPr>
          <a:xfrm rot="20269784">
            <a:off x="6530831" y="211784"/>
            <a:ext cx="332142" cy="2299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70000"/>
              </a:lnSpc>
            </a:pPr>
            <a:r>
              <a:rPr lang="en-US" sz="1200" dirty="0"/>
              <a:t>LR</a:t>
            </a:r>
          </a:p>
        </p:txBody>
      </p:sp>
      <p:sp>
        <p:nvSpPr>
          <p:cNvPr id="3" name="Rounded Rectangle 2"/>
          <p:cNvSpPr/>
          <p:nvPr/>
        </p:nvSpPr>
        <p:spPr>
          <a:xfrm>
            <a:off x="4772938" y="1874520"/>
            <a:ext cx="2589543" cy="480060"/>
          </a:xfrm>
          <a:prstGeom prst="roundRect">
            <a:avLst/>
          </a:prstGeom>
          <a:noFill/>
          <a:ln w="1270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ounded Rectangle 9"/>
          <p:cNvSpPr/>
          <p:nvPr/>
        </p:nvSpPr>
        <p:spPr>
          <a:xfrm>
            <a:off x="4772935" y="3115862"/>
            <a:ext cx="2589543" cy="353332"/>
          </a:xfrm>
          <a:prstGeom prst="roundRect">
            <a:avLst/>
          </a:prstGeom>
          <a:noFill/>
          <a:ln w="1270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ounded Rectangle 10"/>
          <p:cNvSpPr/>
          <p:nvPr/>
        </p:nvSpPr>
        <p:spPr>
          <a:xfrm>
            <a:off x="4772936" y="3654881"/>
            <a:ext cx="2589543" cy="134337"/>
          </a:xfrm>
          <a:prstGeom prst="roundRect">
            <a:avLst/>
          </a:prstGeom>
          <a:noFill/>
          <a:ln w="1270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ounded Rectangle 11"/>
          <p:cNvSpPr/>
          <p:nvPr/>
        </p:nvSpPr>
        <p:spPr>
          <a:xfrm>
            <a:off x="4772935" y="6567054"/>
            <a:ext cx="2589543" cy="207123"/>
          </a:xfrm>
          <a:prstGeom prst="roundRect">
            <a:avLst/>
          </a:prstGeom>
          <a:noFill/>
          <a:ln w="1270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TextBox 12"/>
          <p:cNvSpPr txBox="1"/>
          <p:nvPr/>
        </p:nvSpPr>
        <p:spPr>
          <a:xfrm rot="16200000">
            <a:off x="8075771" y="5393514"/>
            <a:ext cx="12793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og (Fold change)</a:t>
            </a:r>
          </a:p>
        </p:txBody>
      </p:sp>
    </p:spTree>
    <p:extLst>
      <p:ext uri="{BB962C8B-B14F-4D97-AF65-F5344CB8AC3E}">
        <p14:creationId xmlns:p14="http://schemas.microsoft.com/office/powerpoint/2010/main" val="39826441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CA1A08F5-1ED4-4BF4-A3D7-CACB656BDF8B}"/>
              </a:ext>
            </a:extLst>
          </p:cNvPr>
          <p:cNvSpPr/>
          <p:nvPr/>
        </p:nvSpPr>
        <p:spPr>
          <a:xfrm>
            <a:off x="681566" y="906535"/>
            <a:ext cx="10828867" cy="33369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  <a:spcAft>
                <a:spcPts val="800"/>
              </a:spcAft>
            </a:pPr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1. The hierarchical clustering of differentially expressed (DE) miRNAs conserved between two pipelines explained in Figure 1C.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Ninety two DE miRNAs were hierarchically clustered following Euclidian algorithm and Ward’s linkage rule. The consistently regulated miRNAs across in at least two temporal phases starting from Early-phase were of particular interest; the corresponding nodes were boxed and the miRNAs were listed in Table 1. The color code corresponding to the log (fold change) was at the right bottom.   </a:t>
            </a:r>
            <a:endParaRPr lang="en-US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6945049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30462" y="878889"/>
            <a:ext cx="4696133" cy="4082413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59798" y="372862"/>
            <a:ext cx="11001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2.</a:t>
            </a:r>
          </a:p>
        </p:txBody>
      </p:sp>
      <p:sp>
        <p:nvSpPr>
          <p:cNvPr id="6" name="TextBox 5"/>
          <p:cNvSpPr txBox="1"/>
          <p:nvPr/>
        </p:nvSpPr>
        <p:spPr>
          <a:xfrm rot="18783719">
            <a:off x="2289095" y="2484050"/>
            <a:ext cx="2849498" cy="400238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pPr algn="r">
              <a:lnSpc>
                <a:spcPct val="70000"/>
              </a:lnSpc>
            </a:pPr>
            <a:r>
              <a:rPr lang="en-US" b="1" dirty="0"/>
              <a:t>89</a:t>
            </a:r>
            <a:r>
              <a:rPr lang="en-US" dirty="0"/>
              <a:t> miRNA enriched networks: </a:t>
            </a:r>
          </a:p>
          <a:p>
            <a:pPr algn="r">
              <a:lnSpc>
                <a:spcPct val="70000"/>
              </a:lnSpc>
            </a:pPr>
            <a:r>
              <a:rPr lang="en-US" dirty="0"/>
              <a:t>Early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2594832" y="828105"/>
            <a:ext cx="2966518" cy="387798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pPr algn="r">
              <a:lnSpc>
                <a:spcPct val="70000"/>
              </a:lnSpc>
            </a:pPr>
            <a:r>
              <a:rPr lang="en-US" b="1" dirty="0"/>
              <a:t>188</a:t>
            </a:r>
            <a:r>
              <a:rPr lang="en-US" dirty="0"/>
              <a:t> miRNA enriched networks: </a:t>
            </a:r>
          </a:p>
          <a:p>
            <a:pPr algn="r">
              <a:lnSpc>
                <a:spcPct val="70000"/>
              </a:lnSpc>
            </a:pPr>
            <a:r>
              <a:rPr lang="en-US" dirty="0"/>
              <a:t>Mid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7195707" y="828105"/>
            <a:ext cx="2966518" cy="387798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pPr>
              <a:lnSpc>
                <a:spcPct val="70000"/>
              </a:lnSpc>
            </a:pPr>
            <a:r>
              <a:rPr lang="en-US" b="1" dirty="0"/>
              <a:t>157</a:t>
            </a:r>
            <a:r>
              <a:rPr lang="en-US" dirty="0"/>
              <a:t> miRNA enriched networks: </a:t>
            </a:r>
          </a:p>
          <a:p>
            <a:pPr>
              <a:lnSpc>
                <a:spcPct val="70000"/>
              </a:lnSpc>
            </a:pPr>
            <a:r>
              <a:rPr lang="en-US" dirty="0"/>
              <a:t>Late</a:t>
            </a:r>
          </a:p>
        </p:txBody>
      </p:sp>
      <p:sp>
        <p:nvSpPr>
          <p:cNvPr id="12" name="TextBox 11"/>
          <p:cNvSpPr txBox="1"/>
          <p:nvPr/>
        </p:nvSpPr>
        <p:spPr>
          <a:xfrm rot="2701212">
            <a:off x="7736678" y="2457551"/>
            <a:ext cx="2849498" cy="387798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pPr>
              <a:lnSpc>
                <a:spcPct val="70000"/>
              </a:lnSpc>
            </a:pPr>
            <a:r>
              <a:rPr lang="en-US" b="1" dirty="0"/>
              <a:t>44 </a:t>
            </a:r>
            <a:r>
              <a:rPr lang="en-US" dirty="0"/>
              <a:t>miRNA enriched networks: </a:t>
            </a:r>
          </a:p>
          <a:p>
            <a:pPr>
              <a:lnSpc>
                <a:spcPct val="70000"/>
              </a:lnSpc>
            </a:pPr>
            <a:r>
              <a:rPr lang="en-US" dirty="0"/>
              <a:t>LR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8CA78069-D73B-4886-B7B2-2ABA8304B2AD}"/>
              </a:ext>
            </a:extLst>
          </p:cNvPr>
          <p:cNvSpPr/>
          <p:nvPr/>
        </p:nvSpPr>
        <p:spPr>
          <a:xfrm>
            <a:off x="2045039" y="5418637"/>
            <a:ext cx="8280400" cy="112094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  <a:spcAft>
                <a:spcPts val="800"/>
              </a:spcAft>
            </a:pPr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2. 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Venn diagram of the functions linked to the miRNAs differentially expressed (DE) in the post-TBI four temporal phases.</a:t>
            </a:r>
            <a:endParaRPr lang="en-US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1793819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59798" y="372862"/>
            <a:ext cx="11001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3.</a:t>
            </a: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85"/>
          <a:stretch/>
        </p:blipFill>
        <p:spPr>
          <a:xfrm rot="5400000">
            <a:off x="1140000" y="2207698"/>
            <a:ext cx="6301370" cy="3001029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3"/>
          <a:srcRect l="1916" t="9284" r="48258" b="77518"/>
          <a:stretch/>
        </p:blipFill>
        <p:spPr>
          <a:xfrm rot="16200000">
            <a:off x="4910969" y="5347305"/>
            <a:ext cx="1556658" cy="51163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 rot="16200000">
            <a:off x="5443950" y="5464619"/>
            <a:ext cx="12793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og (Fold change)</a:t>
            </a:r>
          </a:p>
        </p:txBody>
      </p:sp>
      <p:sp>
        <p:nvSpPr>
          <p:cNvPr id="8" name="TextBox 7"/>
          <p:cNvSpPr txBox="1"/>
          <p:nvPr/>
        </p:nvSpPr>
        <p:spPr>
          <a:xfrm rot="18104776">
            <a:off x="3203033" y="234362"/>
            <a:ext cx="4882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Early</a:t>
            </a:r>
          </a:p>
        </p:txBody>
      </p:sp>
      <p:sp>
        <p:nvSpPr>
          <p:cNvPr id="9" name="TextBox 8"/>
          <p:cNvSpPr txBox="1"/>
          <p:nvPr/>
        </p:nvSpPr>
        <p:spPr>
          <a:xfrm rot="17846479">
            <a:off x="3495784" y="289552"/>
            <a:ext cx="4315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Mid</a:t>
            </a:r>
          </a:p>
        </p:txBody>
      </p:sp>
      <p:sp>
        <p:nvSpPr>
          <p:cNvPr id="10" name="TextBox 9"/>
          <p:cNvSpPr txBox="1"/>
          <p:nvPr/>
        </p:nvSpPr>
        <p:spPr>
          <a:xfrm rot="18020602">
            <a:off x="3720314" y="281719"/>
            <a:ext cx="4476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te</a:t>
            </a:r>
          </a:p>
        </p:txBody>
      </p:sp>
      <p:sp>
        <p:nvSpPr>
          <p:cNvPr id="11" name="TextBox 10"/>
          <p:cNvSpPr txBox="1"/>
          <p:nvPr/>
        </p:nvSpPr>
        <p:spPr>
          <a:xfrm rot="18457346">
            <a:off x="4008035" y="373045"/>
            <a:ext cx="332142" cy="2299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70000"/>
              </a:lnSpc>
            </a:pPr>
            <a:r>
              <a:rPr lang="en-US" sz="1200" dirty="0"/>
              <a:t>LR</a:t>
            </a:r>
          </a:p>
        </p:txBody>
      </p:sp>
    </p:spTree>
    <p:extLst>
      <p:ext uri="{BB962C8B-B14F-4D97-AF65-F5344CB8AC3E}">
        <p14:creationId xmlns:p14="http://schemas.microsoft.com/office/powerpoint/2010/main" val="27932950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BC51C853-2CDB-4BE7-9A8F-02C64BDE53C1}"/>
              </a:ext>
            </a:extLst>
          </p:cNvPr>
          <p:cNvSpPr/>
          <p:nvPr/>
        </p:nvSpPr>
        <p:spPr>
          <a:xfrm>
            <a:off x="474133" y="778933"/>
            <a:ext cx="11717867" cy="167494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  <a:spcAft>
                <a:spcPts val="800"/>
              </a:spcAft>
            </a:pPr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3. The hierarchical clustering of differentially expressed (DE) miRNAs linked to cancer.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One hundred and three DE miRNAs were hierarchically clustered following Euclidian algorithm and Ward’s linkage rule. The color code corresponding to the log(fold change) was at the right bottom.   </a:t>
            </a:r>
            <a:endParaRPr lang="en-US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626135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7296</TotalTime>
  <Words>214</Words>
  <Application>Microsoft Office PowerPoint</Application>
  <PresentationFormat>Widescreen</PresentationFormat>
  <Paragraphs>24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DH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kraborty, Nabarun M CTR (US)</dc:creator>
  <cp:lastModifiedBy>SANCHITA GHOSH</cp:lastModifiedBy>
  <cp:revision>135</cp:revision>
  <dcterms:created xsi:type="dcterms:W3CDTF">2020-05-11T19:04:04Z</dcterms:created>
  <dcterms:modified xsi:type="dcterms:W3CDTF">2023-06-26T11:44:54Z</dcterms:modified>
</cp:coreProperties>
</file>